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725" y="48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7180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991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2028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647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98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6151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067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6010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793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398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77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31FAE-3968-4B9D-83EA-2AD1CEEE46C7}" type="datetimeFigureOut">
              <a:rPr lang="zh-CN" altLang="en-US" smtClean="0"/>
              <a:t>2024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435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950749" y="639238"/>
            <a:ext cx="5095158" cy="7005842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87830B8C-83E9-4C3C-BEC2-4DF3E10EB11F}"/>
              </a:ext>
            </a:extLst>
          </p:cNvPr>
          <p:cNvSpPr/>
          <p:nvPr/>
        </p:nvSpPr>
        <p:spPr>
          <a:xfrm>
            <a:off x="1983540" y="1012959"/>
            <a:ext cx="127646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425102" y="3304092"/>
            <a:ext cx="585417" cy="276999"/>
            <a:chOff x="-4002962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3450498" y="4043657"/>
            <a:ext cx="585417" cy="276999"/>
            <a:chOff x="-4002962" y="10215563"/>
            <a:chExt cx="585417" cy="276999"/>
          </a:xfrm>
        </p:grpSpPr>
        <p:sp>
          <p:nvSpPr>
            <p:cNvPr id="16" name="矩形 15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/>
          <p:cNvGrpSpPr/>
          <p:nvPr/>
        </p:nvGrpSpPr>
        <p:grpSpPr>
          <a:xfrm>
            <a:off x="7561718" y="2176428"/>
            <a:ext cx="1364476" cy="1097757"/>
            <a:chOff x="11388749" y="871520"/>
            <a:chExt cx="1364476" cy="1097757"/>
          </a:xfrm>
        </p:grpSpPr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11447425" y="1408163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11388749" y="1107427"/>
              <a:ext cx="13644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PDAC-CN1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259913" y="1235733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804420" y="1475935"/>
              <a:ext cx="58481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2186306" y="1427892"/>
              <a:ext cx="687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矩形 17"/>
          <p:cNvSpPr/>
          <p:nvPr/>
        </p:nvSpPr>
        <p:spPr>
          <a:xfrm>
            <a:off x="7619515" y="3212528"/>
            <a:ext cx="1332779" cy="386895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842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9790" y="-606247"/>
            <a:ext cx="6219262" cy="8551485"/>
          </a:xfrm>
          <a:prstGeom prst="rect">
            <a:avLst/>
          </a:prstGeom>
        </p:spPr>
      </p:pic>
      <p:grpSp>
        <p:nvGrpSpPr>
          <p:cNvPr id="11" name="组合 10"/>
          <p:cNvGrpSpPr/>
          <p:nvPr/>
        </p:nvGrpSpPr>
        <p:grpSpPr>
          <a:xfrm>
            <a:off x="3931966" y="6581001"/>
            <a:ext cx="670376" cy="276999"/>
            <a:chOff x="-4088306" y="10215563"/>
            <a:chExt cx="670376" cy="276999"/>
          </a:xfrm>
        </p:grpSpPr>
        <p:sp>
          <p:nvSpPr>
            <p:cNvPr id="12" name="矩形 11"/>
            <p:cNvSpPr/>
            <p:nvPr/>
          </p:nvSpPr>
          <p:spPr>
            <a:xfrm>
              <a:off x="-4088306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矩形 21">
            <a:extLst>
              <a:ext uri="{FF2B5EF4-FFF2-40B4-BE49-F238E27FC236}">
                <a16:creationId xmlns:a16="http://schemas.microsoft.com/office/drawing/2014/main" id="{87830B8C-83E9-4C3C-BEC2-4DF3E10EB11F}"/>
              </a:ext>
            </a:extLst>
          </p:cNvPr>
          <p:cNvSpPr/>
          <p:nvPr/>
        </p:nvSpPr>
        <p:spPr>
          <a:xfrm>
            <a:off x="239621" y="1331935"/>
            <a:ext cx="127646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5199518" y="3959508"/>
            <a:ext cx="1364476" cy="1097757"/>
            <a:chOff x="11388749" y="871520"/>
            <a:chExt cx="1364476" cy="1097757"/>
          </a:xfrm>
        </p:grpSpPr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11447425" y="1408163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11388749" y="1107427"/>
              <a:ext cx="13644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PDAC-CN1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259913" y="1235733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804420" y="1475935"/>
              <a:ext cx="58481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2186306" y="1427892"/>
              <a:ext cx="687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矩形 13"/>
          <p:cNvSpPr/>
          <p:nvPr/>
        </p:nvSpPr>
        <p:spPr>
          <a:xfrm>
            <a:off x="5245099" y="5030180"/>
            <a:ext cx="1332779" cy="357728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309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2169" y="-2017395"/>
            <a:ext cx="7014274" cy="9644627"/>
          </a:xfrm>
          <a:prstGeom prst="rect">
            <a:avLst/>
          </a:prstGeom>
        </p:spPr>
      </p:pic>
      <p:grpSp>
        <p:nvGrpSpPr>
          <p:cNvPr id="12" name="组合 11"/>
          <p:cNvGrpSpPr/>
          <p:nvPr/>
        </p:nvGrpSpPr>
        <p:grpSpPr>
          <a:xfrm>
            <a:off x="2911256" y="6406509"/>
            <a:ext cx="670376" cy="276999"/>
            <a:chOff x="-4088306" y="10215563"/>
            <a:chExt cx="670376" cy="276999"/>
          </a:xfrm>
        </p:grpSpPr>
        <p:sp>
          <p:nvSpPr>
            <p:cNvPr id="13" name="矩形 12"/>
            <p:cNvSpPr/>
            <p:nvPr/>
          </p:nvSpPr>
          <p:spPr>
            <a:xfrm>
              <a:off x="-4088306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" name="矩形 30"/>
          <p:cNvSpPr/>
          <p:nvPr/>
        </p:nvSpPr>
        <p:spPr>
          <a:xfrm>
            <a:off x="994676" y="1381672"/>
            <a:ext cx="17577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RKDC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Ser2056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3947933" y="4210968"/>
            <a:ext cx="1364476" cy="1097757"/>
            <a:chOff x="11388749" y="871520"/>
            <a:chExt cx="1364476" cy="1097757"/>
          </a:xfrm>
        </p:grpSpPr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11447425" y="1408163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11388749" y="1107427"/>
              <a:ext cx="13644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PDAC-CN1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259913" y="1235733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804420" y="1475935"/>
              <a:ext cx="58481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2186306" y="1427892"/>
              <a:ext cx="687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矩形 14"/>
          <p:cNvSpPr/>
          <p:nvPr/>
        </p:nvSpPr>
        <p:spPr>
          <a:xfrm>
            <a:off x="3843830" y="5150982"/>
            <a:ext cx="1686385" cy="488386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08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图片 3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3646" y="-420463"/>
            <a:ext cx="6046371" cy="831376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327145F1-DEF5-43BB-BF9A-9191F1AFAE2D}"/>
              </a:ext>
            </a:extLst>
          </p:cNvPr>
          <p:cNvSpPr/>
          <p:nvPr/>
        </p:nvSpPr>
        <p:spPr>
          <a:xfrm>
            <a:off x="2076138" y="1027337"/>
            <a:ext cx="68480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 flipH="1">
            <a:off x="7034921" y="3701317"/>
            <a:ext cx="585417" cy="276999"/>
            <a:chOff x="-4002962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 flipH="1">
            <a:off x="7059973" y="4172219"/>
            <a:ext cx="585417" cy="276999"/>
            <a:chOff x="-4002962" y="10215563"/>
            <a:chExt cx="585417" cy="276999"/>
          </a:xfrm>
        </p:grpSpPr>
        <p:sp>
          <p:nvSpPr>
            <p:cNvPr id="16" name="矩形 15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2" name="直接箭头连接符 31"/>
          <p:cNvCxnSpPr/>
          <p:nvPr/>
        </p:nvCxnSpPr>
        <p:spPr>
          <a:xfrm flipH="1">
            <a:off x="7017964" y="3957996"/>
            <a:ext cx="9448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" name="组合 33"/>
          <p:cNvGrpSpPr/>
          <p:nvPr/>
        </p:nvGrpSpPr>
        <p:grpSpPr>
          <a:xfrm>
            <a:off x="5138558" y="2363859"/>
            <a:ext cx="1364476" cy="1097757"/>
            <a:chOff x="11388749" y="871520"/>
            <a:chExt cx="1364476" cy="1097757"/>
          </a:xfrm>
        </p:grpSpPr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11447425" y="1408163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11388749" y="1107427"/>
              <a:ext cx="13644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PDAC-CN1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259913" y="1235733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1804420" y="1475935"/>
              <a:ext cx="58481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12186306" y="1427892"/>
              <a:ext cx="687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组合 40"/>
          <p:cNvGrpSpPr/>
          <p:nvPr/>
        </p:nvGrpSpPr>
        <p:grpSpPr>
          <a:xfrm flipH="1">
            <a:off x="7060311" y="4663440"/>
            <a:ext cx="670376" cy="276999"/>
            <a:chOff x="-4087921" y="10215563"/>
            <a:chExt cx="670376" cy="276999"/>
          </a:xfrm>
        </p:grpSpPr>
        <p:sp>
          <p:nvSpPr>
            <p:cNvPr id="42" name="矩形 41"/>
            <p:cNvSpPr/>
            <p:nvPr/>
          </p:nvSpPr>
          <p:spPr>
            <a:xfrm>
              <a:off x="-4087921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接连接符 42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" name="矩形 19"/>
          <p:cNvSpPr/>
          <p:nvPr/>
        </p:nvSpPr>
        <p:spPr>
          <a:xfrm>
            <a:off x="5115844" y="3792259"/>
            <a:ext cx="1387190" cy="379960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947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34</Words>
  <Application>Microsoft Office PowerPoint</Application>
  <PresentationFormat>宽屏</PresentationFormat>
  <Paragraphs>27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15</cp:revision>
  <dcterms:created xsi:type="dcterms:W3CDTF">2024-02-08T04:45:53Z</dcterms:created>
  <dcterms:modified xsi:type="dcterms:W3CDTF">2024-03-04T12:45:41Z</dcterms:modified>
</cp:coreProperties>
</file>